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558" r:id="rId2"/>
    <p:sldId id="557" r:id="rId3"/>
    <p:sldId id="554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1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4EF49C-7C1B-42AA-9FC4-52B486C4131C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8E178D-9635-404F-AA58-A7DCD3CC0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8233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22" name="Slide Image Placeholder 1">
            <a:extLst>
              <a:ext uri="{FF2B5EF4-FFF2-40B4-BE49-F238E27FC236}">
                <a16:creationId xmlns:a16="http://schemas.microsoft.com/office/drawing/2014/main" id="{0AA457D5-BCA1-4F04-A1D8-7FDDC54732CC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81923" name="Notes Placeholder 2">
            <a:extLst>
              <a:ext uri="{FF2B5EF4-FFF2-40B4-BE49-F238E27FC236}">
                <a16:creationId xmlns:a16="http://schemas.microsoft.com/office/drawing/2014/main" id="{015C9E73-C47D-4246-BE6D-F6AEB5493C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altLang="en-US">
              <a:latin typeface="Arial" panose="020B0604020202020204" pitchFamily="34" charset="0"/>
            </a:endParaRPr>
          </a:p>
        </p:txBody>
      </p:sp>
      <p:sp>
        <p:nvSpPr>
          <p:cNvPr id="81924" name="Slide Number Placeholder 3">
            <a:extLst>
              <a:ext uri="{FF2B5EF4-FFF2-40B4-BE49-F238E27FC236}">
                <a16:creationId xmlns:a16="http://schemas.microsoft.com/office/drawing/2014/main" id="{65033C9A-380E-481C-AC25-D000F75D573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 eaLnBrk="1" hangingPunct="1"/>
            <a:fld id="{4B2BB57A-2385-412F-8F14-545E751D6989}" type="slidenum">
              <a:rPr lang="en-US" altLang="en-US" sz="1200">
                <a:latin typeface="Arial" panose="020B0604020202020204" pitchFamily="34" charset="0"/>
              </a:rPr>
              <a:pPr eaLnBrk="1" hangingPunct="1"/>
              <a:t>2</a:t>
            </a:fld>
            <a:endParaRPr lang="en-US" altLang="en-US" sz="1200">
              <a:latin typeface="Arial" panose="020B0604020202020204" pitchFamily="34" charset="0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946" name="Slide Image Placeholder 1">
            <a:extLst>
              <a:ext uri="{FF2B5EF4-FFF2-40B4-BE49-F238E27FC236}">
                <a16:creationId xmlns:a16="http://schemas.microsoft.com/office/drawing/2014/main" id="{B67C364C-BD69-4F43-895D-CC2F006CFC29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82947" name="Notes Placeholder 2">
            <a:extLst>
              <a:ext uri="{FF2B5EF4-FFF2-40B4-BE49-F238E27FC236}">
                <a16:creationId xmlns:a16="http://schemas.microsoft.com/office/drawing/2014/main" id="{980A9311-2BE6-4BB5-9D15-28A8D4DB01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altLang="en-US">
              <a:latin typeface="Arial" panose="020B0604020202020204" pitchFamily="34" charset="0"/>
            </a:endParaRPr>
          </a:p>
        </p:txBody>
      </p:sp>
      <p:sp>
        <p:nvSpPr>
          <p:cNvPr id="82948" name="Slide Number Placeholder 3">
            <a:extLst>
              <a:ext uri="{FF2B5EF4-FFF2-40B4-BE49-F238E27FC236}">
                <a16:creationId xmlns:a16="http://schemas.microsoft.com/office/drawing/2014/main" id="{8F808AA0-BDAC-42F7-BAF3-4062FF4D7DF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 eaLnBrk="1" hangingPunct="1"/>
            <a:fld id="{B61312CF-6A5F-43E8-A0E5-FE978A682079}" type="slidenum">
              <a:rPr lang="en-US" altLang="en-US" sz="1200">
                <a:latin typeface="Arial" panose="020B0604020202020204" pitchFamily="34" charset="0"/>
              </a:rPr>
              <a:pPr eaLnBrk="1" hangingPunct="1"/>
              <a:t>3</a:t>
            </a:fld>
            <a:endParaRPr lang="en-US" altLang="en-US" sz="1200">
              <a:latin typeface="Arial" panose="020B0604020202020204" pitchFamily="34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31D2D4-CD55-4D8F-969A-A275EB5360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475490-8B85-4B1A-AC00-C4B1D94C3A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1EBDC3-D28B-4377-BCB1-C8F7A08B6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CEEC3A-577B-4807-B6DC-65E0600C43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FFC2E6-D6A2-48D6-B263-066C18906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65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D8C571-2639-467B-97B7-60A5C8324D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A1AEFE-4AC3-4198-B179-140ACD1CD6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E59CF8-421B-43FC-B4E5-B79B3543B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1B8382-5A9E-46A7-B38F-D02CDF5B0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825B45-CD00-4329-AD0E-70A4E36C9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17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246E01-47D9-4982-BE82-26AAA93FA5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FFA626-2A1B-4F6F-AA99-AEDB7AA6D7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2C43E5-C3F7-4437-B3F3-F0A05BE84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FAF88F-C725-4577-A746-66A4C72835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5557BA-0449-4722-A0B3-637BCE6A5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155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8D430C-8449-4C2D-B1E1-4DF5C9A875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1695B1-4226-4809-9C95-A943C49A9A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1A91FB-36BC-4904-8BB8-AF4FB92DF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5A88E0-40F2-4BC3-8D98-1137CA949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338010-436F-453C-B53A-3231962AC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510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FE2318-F5C8-415F-9823-9B02881D9B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F9DFAD-7F40-41BF-B6A6-3A4F70F687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F3619D-9356-4301-90EC-BD4D6E300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577C15-18B3-4A82-AD7B-A33327A78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952766-110C-43DE-925F-97E9A7B70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269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75467C-E0C0-4102-A540-96CBA9DA6B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7F0A99-46A6-40C2-B52D-1468EABBE0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9F02B4-798D-4237-9F9D-A782D31A7C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C2289A-6B01-4990-8B16-5DBFAE92C9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D4A697-FAF1-451E-B1BB-A6DA81474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588EAF-7A28-4C09-A62A-5C061DB87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194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048A18-A840-4DFF-96AA-CDB13E076E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2E94F6-82BA-49DD-AA70-7B6631D8EE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8D7ABF-F088-4053-92B3-FBCA304F9C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2B63C6-F467-41A8-AA44-6DA0505CA7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780B25-E257-4132-B139-6A43F3AC5A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36CEAB1-EECE-4761-98B8-1514C8588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51EA83-4D9E-4945-98F4-E41224C2F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907A20-F58C-4F87-AB23-569655FF4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526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F2A2AC-78ED-43C9-B761-C2E5542F6D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88DAD6A-DA3F-4C18-8099-A24373DC0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320345-4EEA-4150-895A-5B227D5C2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7F57E06-EC8E-465F-8B8B-1DBB747F2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738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74C8DD-279D-47BC-80C2-3922C4D53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E4A021-6144-4E4B-844E-242C5C56F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C9CCA4-6B1A-4783-9A7E-09E93608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737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DA7AC1-F80B-479C-A562-814BF4D498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09573B-72D0-4949-A76D-47F95C6856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EC9DA5-B44E-4FC5-B998-618BD2C0A2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EE4716-F068-44BD-AE8B-BB9007B8B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E91D4E-942D-4A8D-8E71-0EC4836A9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7CD5E7-A71A-4EBB-9DAD-E3BE0050D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583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C55298-2D03-4AD4-AA81-B5FB93F17D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86754D-4D05-42BE-86BC-9C36D44070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AE4909-5B04-4ABE-A15A-3A7EE0D229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BEA060-C0A2-487F-99AE-780678FBC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2B39DB-D6D3-4B54-800D-A3FABFBA7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34192E-D802-4FBF-BD1D-9A5CDF8BD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0573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18EE60-0781-4F4F-8F1A-7571542E8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562F22-F91A-4950-A3FF-A9A8E32B43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DBF670-C2F0-45B5-A169-307ABD2844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B9032-82E3-4B11-A4D9-0E4CB736ED7F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F0D454-A6E0-45B7-8D6E-9889118597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6957DF-6A7F-4126-A832-C7B4FD7A4F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2CE8EA-04DF-42C4-BA63-11C389B95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369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7746C1-7BF2-4E83-9E5E-856B57B0CA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9726" y="1912571"/>
            <a:ext cx="10515600" cy="1325563"/>
          </a:xfrm>
        </p:spPr>
        <p:txBody>
          <a:bodyPr>
            <a:normAutofit fontScale="90000"/>
          </a:bodyPr>
          <a:lstStyle/>
          <a:p>
            <a:r>
              <a:rPr lang="en-US" dirty="0"/>
              <a:t>Cross correlations of single units.</a:t>
            </a:r>
            <a:br>
              <a:rPr lang="en-US" dirty="0"/>
            </a:br>
            <a:br>
              <a:rPr lang="en-US" dirty="0"/>
            </a:br>
            <a:r>
              <a:rPr lang="en-US" dirty="0"/>
              <a:t>Author: Phil Kennedy</a:t>
            </a:r>
            <a:br>
              <a:rPr lang="en-US" dirty="0"/>
            </a:br>
            <a:br>
              <a:rPr lang="en-US" dirty="0"/>
            </a:br>
            <a:r>
              <a:rPr lang="en-US" dirty="0"/>
              <a:t>Additional materials</a:t>
            </a:r>
          </a:p>
        </p:txBody>
      </p:sp>
    </p:spTree>
    <p:extLst>
      <p:ext uri="{BB962C8B-B14F-4D97-AF65-F5344CB8AC3E}">
        <p14:creationId xmlns:p14="http://schemas.microsoft.com/office/powerpoint/2010/main" val="33156816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0" name="Title 1">
            <a:extLst>
              <a:ext uri="{FF2B5EF4-FFF2-40B4-BE49-F238E27FC236}">
                <a16:creationId xmlns:a16="http://schemas.microsoft.com/office/drawing/2014/main" id="{A14629BB-3F03-4200-8617-E96CBCF83C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85940" y="373065"/>
            <a:ext cx="8672510" cy="316252"/>
          </a:xfrm>
        </p:spPr>
        <p:txBody>
          <a:bodyPr>
            <a:noAutofit/>
          </a:bodyPr>
          <a:lstStyle/>
          <a:p>
            <a:r>
              <a:rPr lang="en-US" altLang="en-US" sz="2800" dirty="0">
                <a:solidFill>
                  <a:schemeClr val="tx1"/>
                </a:solidFill>
              </a:rPr>
              <a:t>Cross-correlations of single unit firings</a:t>
            </a: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424EF72C-F41E-4B94-A152-FDA267376A05}"/>
              </a:ext>
            </a:extLst>
          </p:cNvPr>
          <p:cNvSpPr txBox="1">
            <a:spLocks/>
          </p:cNvSpPr>
          <p:nvPr/>
        </p:nvSpPr>
        <p:spPr bwMode="auto">
          <a:xfrm>
            <a:off x="3962400" y="2373313"/>
            <a:ext cx="38862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normAutofit fontScale="97500"/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rgbClr val="0950A0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rgbClr val="0950A0"/>
                </a:solidFill>
                <a:latin typeface="Arial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rgbClr val="0950A0"/>
                </a:solidFill>
                <a:latin typeface="Arial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rgbClr val="0950A0"/>
                </a:solidFill>
                <a:latin typeface="Arial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rgbClr val="0950A0"/>
                </a:solidFill>
                <a:latin typeface="Arial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2400" b="1">
                <a:solidFill>
                  <a:srgbClr val="0950A0"/>
                </a:solidFill>
                <a:latin typeface="Arial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2400" b="1">
                <a:solidFill>
                  <a:srgbClr val="0950A0"/>
                </a:solidFill>
                <a:latin typeface="Arial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2400" b="1">
                <a:solidFill>
                  <a:srgbClr val="0950A0"/>
                </a:solidFill>
                <a:latin typeface="Arial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2400" b="1">
                <a:solidFill>
                  <a:srgbClr val="0950A0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dirty="0"/>
              <a:t>2-17 Correlations</a:t>
            </a:r>
            <a:br>
              <a:rPr lang="en-US" dirty="0"/>
            </a:br>
            <a:br>
              <a:rPr lang="en-US" dirty="0"/>
            </a:br>
            <a:r>
              <a:rPr lang="en-US" dirty="0">
                <a:solidFill>
                  <a:srgbClr val="FF0000"/>
                </a:solidFill>
              </a:rPr>
              <a:t>C4</a:t>
            </a:r>
            <a:r>
              <a:rPr lang="en-US" dirty="0"/>
              <a:t>  Day 1556 </a:t>
            </a:r>
          </a:p>
        </p:txBody>
      </p:sp>
      <p:sp>
        <p:nvSpPr>
          <p:cNvPr id="4" name="Subtitle 2">
            <a:extLst>
              <a:ext uri="{FF2B5EF4-FFF2-40B4-BE49-F238E27FC236}">
                <a16:creationId xmlns:a16="http://schemas.microsoft.com/office/drawing/2014/main" id="{2114F417-532A-43A4-86FD-C889620E1057}"/>
              </a:ext>
            </a:extLst>
          </p:cNvPr>
          <p:cNvSpPr txBox="1">
            <a:spLocks/>
          </p:cNvSpPr>
          <p:nvPr/>
        </p:nvSpPr>
        <p:spPr>
          <a:xfrm>
            <a:off x="3584575" y="4060825"/>
            <a:ext cx="4641850" cy="979488"/>
          </a:xfrm>
          <a:prstGeom prst="rect">
            <a:avLst/>
          </a:prstGeom>
        </p:spPr>
        <p:txBody>
          <a:bodyPr>
            <a:normAutofit fontScale="25000" lnSpcReduction="20000"/>
          </a:bodyPr>
          <a:lstStyle>
            <a:lvl1pPr marL="342900" indent="-342900" algn="l" rtl="0" eaLnBrk="0" fontAlgn="base" hangingPunct="0">
              <a:lnSpc>
                <a:spcPct val="160000"/>
              </a:lnSpc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Font typeface="Wingdings" pitchFamily="2" charset="2"/>
              <a:buChar char="§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Char char="–"/>
              <a:defRPr sz="16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Char char="•"/>
              <a:defRPr sz="1600">
                <a:solidFill>
                  <a:schemeClr val="tx1"/>
                </a:solidFill>
                <a:latin typeface="+mn-lt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Char char="–"/>
              <a:defRPr sz="14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Char char="»"/>
              <a:defRPr sz="1400">
                <a:solidFill>
                  <a:schemeClr val="tx1"/>
                </a:solidFill>
                <a:latin typeface="+mn-lt"/>
              </a:defRPr>
            </a:lvl5pPr>
            <a:lvl6pPr marL="2514600" indent="-228600" algn="l" rtl="0" fontAlgn="base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Char char="»"/>
              <a:defRPr sz="1400">
                <a:solidFill>
                  <a:schemeClr val="tx1"/>
                </a:solidFill>
                <a:latin typeface="+mn-lt"/>
              </a:defRPr>
            </a:lvl6pPr>
            <a:lvl7pPr marL="2971800" indent="-228600" algn="l" rtl="0" fontAlgn="base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Char char="»"/>
              <a:defRPr sz="1400">
                <a:solidFill>
                  <a:schemeClr val="tx1"/>
                </a:solidFill>
                <a:latin typeface="+mn-lt"/>
              </a:defRPr>
            </a:lvl7pPr>
            <a:lvl8pPr marL="3429000" indent="-228600" algn="l" rtl="0" fontAlgn="base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Char char="»"/>
              <a:defRPr sz="1400">
                <a:solidFill>
                  <a:schemeClr val="tx1"/>
                </a:solidFill>
                <a:latin typeface="+mn-lt"/>
              </a:defRPr>
            </a:lvl8pPr>
            <a:lvl9pPr marL="3886200" indent="-228600" algn="l" rtl="0" fontAlgn="base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Char char="»"/>
              <a:defRPr sz="14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defRPr/>
            </a:pPr>
            <a:endParaRPr lang="en-US" sz="4000" dirty="0"/>
          </a:p>
          <a:p>
            <a:pPr algn="ctr">
              <a:defRPr/>
            </a:pPr>
            <a:r>
              <a:rPr lang="en-US" sz="9600" b="1" dirty="0"/>
              <a:t>Listen – Control - Sing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91FDAF3-EE1A-46DB-A82F-2EBC083FCE2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7676" y="1008063"/>
            <a:ext cx="6742113" cy="5484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 descr="C:\Documents and Settings\user\My Documents\Phil\Neural Signals\Data Analysis\Cortical maps\2-17\cortical map 2-17 Listen C4 4.bmp">
            <a:extLst>
              <a:ext uri="{FF2B5EF4-FFF2-40B4-BE49-F238E27FC236}">
                <a16:creationId xmlns:a16="http://schemas.microsoft.com/office/drawing/2014/main" id="{77ADF9F2-F99E-406D-8CBF-312282A783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939" y="968375"/>
            <a:ext cx="8620125" cy="560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" descr="C:\Documents and Settings\user\My Documents\Phil\Neural Signals\Data Analysis\Cortical maps\2-17\cortical map 2-17 Control C4 4.bmp">
            <a:extLst>
              <a:ext uri="{FF2B5EF4-FFF2-40B4-BE49-F238E27FC236}">
                <a16:creationId xmlns:a16="http://schemas.microsoft.com/office/drawing/2014/main" id="{87A3029E-4115-4D32-8F11-6101493A20D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6250" y="9747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2" descr="C:\Documents and Settings\user\My Documents\Phil\Neural Signals\Data Analysis\Cortical maps\2-17\cortical map 2-17 Sing C4 4.bmp">
            <a:extLst>
              <a:ext uri="{FF2B5EF4-FFF2-40B4-BE49-F238E27FC236}">
                <a16:creationId xmlns:a16="http://schemas.microsoft.com/office/drawing/2014/main" id="{B14EEB93-4168-40A1-9CDB-9C148FD449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" descr="C:\Documents and Settings\user\My Documents\Phil\Neural Signals\Data Analysis\Cortical maps\2-17\cortical map 2-17 Listen C4 5.bmp">
            <a:extLst>
              <a:ext uri="{FF2B5EF4-FFF2-40B4-BE49-F238E27FC236}">
                <a16:creationId xmlns:a16="http://schemas.microsoft.com/office/drawing/2014/main" id="{B2D4ABB7-89B1-4639-AFB1-445A3CB515F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939" y="981075"/>
            <a:ext cx="8620125" cy="560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2" descr="C:\Documents and Settings\user\My Documents\Phil\Neural Signals\Data Analysis\Cortical maps\2-17\cortical map 2-17 Control C4 5.bmp">
            <a:extLst>
              <a:ext uri="{FF2B5EF4-FFF2-40B4-BE49-F238E27FC236}">
                <a16:creationId xmlns:a16="http://schemas.microsoft.com/office/drawing/2014/main" id="{C95EF3DA-66D3-454C-B1B0-662E8B56773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4" descr="C:\Documents and Settings\user\My Documents\Phil\Neural Signals\Data Analysis\Cortical maps\2-17\cortical map 2-17 Sing C4 5.bmp">
            <a:extLst>
              <a:ext uri="{FF2B5EF4-FFF2-40B4-BE49-F238E27FC236}">
                <a16:creationId xmlns:a16="http://schemas.microsoft.com/office/drawing/2014/main" id="{BB39E276-9BFE-4473-9344-050E6157DD2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2" descr="C:\Documents and Settings\user\My Documents\Phil\Neural Signals\Data Analysis\Cortical maps\2-17\cortical map 2-17 Listen C4 6.bmp">
            <a:extLst>
              <a:ext uri="{FF2B5EF4-FFF2-40B4-BE49-F238E27FC236}">
                <a16:creationId xmlns:a16="http://schemas.microsoft.com/office/drawing/2014/main" id="{C32E3179-C8E4-44C3-BDAF-6FB1B4D2C66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939" y="993775"/>
            <a:ext cx="8620125" cy="560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2" descr="C:\Documents and Settings\user\My Documents\Phil\Neural Signals\Data Analysis\Cortical maps\2-17\cortical map 2-17 Control C4 6.bmp">
            <a:extLst>
              <a:ext uri="{FF2B5EF4-FFF2-40B4-BE49-F238E27FC236}">
                <a16:creationId xmlns:a16="http://schemas.microsoft.com/office/drawing/2014/main" id="{3F982FFF-FCFA-41EA-8A75-6D261CB831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2" descr="C:\Documents and Settings\user\My Documents\Phil\Neural Signals\Data Analysis\Cortical maps\2-17\cortical map 2-17 Sing C4 6.bmp">
            <a:extLst>
              <a:ext uri="{FF2B5EF4-FFF2-40B4-BE49-F238E27FC236}">
                <a16:creationId xmlns:a16="http://schemas.microsoft.com/office/drawing/2014/main" id="{7E4B52EC-824F-47E7-BCD9-CB307FE48E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2" descr="C:\Documents and Settings\user\My Documents\Phil\Neural Signals\Data Analysis\Cortical maps\2-17\cortical map 2-17 Listen C4 7.bmp">
            <a:extLst>
              <a:ext uri="{FF2B5EF4-FFF2-40B4-BE49-F238E27FC236}">
                <a16:creationId xmlns:a16="http://schemas.microsoft.com/office/drawing/2014/main" id="{F4BD4293-1F74-4EFC-AFA1-A8D02B1A2E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939" y="993775"/>
            <a:ext cx="8620125" cy="560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2" descr="C:\Documents and Settings\user\My Documents\Phil\Neural Signals\Data Analysis\Cortical maps\2-17\cortical map 2-17 Control C4 7.bmp">
            <a:extLst>
              <a:ext uri="{FF2B5EF4-FFF2-40B4-BE49-F238E27FC236}">
                <a16:creationId xmlns:a16="http://schemas.microsoft.com/office/drawing/2014/main" id="{1650A478-B342-48CF-8E84-ECA2B7D93C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2" descr="C:\Documents and Settings\user\My Documents\Phil\Neural Signals\Data Analysis\Cortical maps\2-17\cortical map 2-17 Sing C4 7.bmp">
            <a:extLst>
              <a:ext uri="{FF2B5EF4-FFF2-40B4-BE49-F238E27FC236}">
                <a16:creationId xmlns:a16="http://schemas.microsoft.com/office/drawing/2014/main" id="{6603E480-CCB4-413A-82EE-8929516FCD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2" descr="C:\Documents and Settings\user\My Documents\Phil\Neural Signals\Data Analysis\Cortical maps\2-17\cortical map 2-17 Sing C4 7.bmp">
            <a:extLst>
              <a:ext uri="{FF2B5EF4-FFF2-40B4-BE49-F238E27FC236}">
                <a16:creationId xmlns:a16="http://schemas.microsoft.com/office/drawing/2014/main" id="{FF710747-3770-44EB-9D6A-AD57EE46A7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2" descr="C:\Documents and Settings\user\My Documents\Phil\Neural Signals\Data Analysis\Cortical maps\2-17\cortical map 2-17 Listen C4 8.bmp">
            <a:extLst>
              <a:ext uri="{FF2B5EF4-FFF2-40B4-BE49-F238E27FC236}">
                <a16:creationId xmlns:a16="http://schemas.microsoft.com/office/drawing/2014/main" id="{222EF135-6EB9-4014-BB9D-7D07CCA94F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939" y="993775"/>
            <a:ext cx="8620125" cy="560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2" descr="C:\Documents and Settings\user\My Documents\Phil\Neural Signals\Data Analysis\Cortical maps\2-17\cortical map 2-17 Control C4 8.bmp">
            <a:extLst>
              <a:ext uri="{FF2B5EF4-FFF2-40B4-BE49-F238E27FC236}">
                <a16:creationId xmlns:a16="http://schemas.microsoft.com/office/drawing/2014/main" id="{F75CEC01-C14B-4AB2-B9CD-8A30203311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" descr="C:\Documents and Settings\user\My Documents\Phil\Neural Signals\Data Analysis\Cortical maps\2-17\cortical map 2-17 Sing C4 8.bmp">
            <a:extLst>
              <a:ext uri="{FF2B5EF4-FFF2-40B4-BE49-F238E27FC236}">
                <a16:creationId xmlns:a16="http://schemas.microsoft.com/office/drawing/2014/main" id="{F1406040-D7A6-4A22-9FE0-A36A3E8F2B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2" descr="C:\Documents and Settings\user\My Documents\Phil\Neural Signals\Data Analysis\Cortical maps\2-17\cortical map 2-17 Listen C4 9.bmp">
            <a:extLst>
              <a:ext uri="{FF2B5EF4-FFF2-40B4-BE49-F238E27FC236}">
                <a16:creationId xmlns:a16="http://schemas.microsoft.com/office/drawing/2014/main" id="{F5A14160-2A87-42B5-9BB4-164168B01AA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939" y="993775"/>
            <a:ext cx="8620125" cy="560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2" descr="C:\Documents and Settings\user\My Documents\Phil\Neural Signals\Data Analysis\Cortical maps\2-17\cortical map 2-17 Control C4 9.bmp">
            <a:extLst>
              <a:ext uri="{FF2B5EF4-FFF2-40B4-BE49-F238E27FC236}">
                <a16:creationId xmlns:a16="http://schemas.microsoft.com/office/drawing/2014/main" id="{F23288D9-A62C-4D35-BAC6-F8522F5D08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2" descr="C:\Documents and Settings\user\My Documents\Phil\Neural Signals\Data Analysis\Cortical maps\2-17\cortical map 2-17 Sing C4 9.bmp">
            <a:extLst>
              <a:ext uri="{FF2B5EF4-FFF2-40B4-BE49-F238E27FC236}">
                <a16:creationId xmlns:a16="http://schemas.microsoft.com/office/drawing/2014/main" id="{ADC86936-83C1-4310-821C-7B0287AF9A0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2" descr="C:\Documents and Settings\user\My Documents\Phil\Neural Signals\Data Analysis\Cortical maps\2-17\cortical map 2-17 Listen C4 10.bmp">
            <a:extLst>
              <a:ext uri="{FF2B5EF4-FFF2-40B4-BE49-F238E27FC236}">
                <a16:creationId xmlns:a16="http://schemas.microsoft.com/office/drawing/2014/main" id="{E61F2E1F-74DF-4D5B-88B4-884240111A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939" y="993775"/>
            <a:ext cx="8620125" cy="560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2" descr="C:\Documents and Settings\user\My Documents\Phil\Neural Signals\Data Analysis\Cortical maps\2-17\cortical map 2-17 Control C4 10.bmp">
            <a:extLst>
              <a:ext uri="{FF2B5EF4-FFF2-40B4-BE49-F238E27FC236}">
                <a16:creationId xmlns:a16="http://schemas.microsoft.com/office/drawing/2014/main" id="{568AFBD2-7EA9-4077-BD73-24BCE3B674D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3550" y="962025"/>
            <a:ext cx="8724900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12369C6-AEA7-4088-B115-F3228C93EC82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755526" y="943320"/>
            <a:ext cx="8724900" cy="5635847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 nodeType="clickPar">
                      <p:stCondLst>
                        <p:cond delay="indefinite"/>
                      </p:stCondLst>
                      <p:childTnLst>
                        <p:par>
                          <p:cTn id="2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 nodeType="clickPar">
                      <p:stCondLst>
                        <p:cond delay="indefinite"/>
                      </p:stCondLst>
                      <p:childTnLst>
                        <p:par>
                          <p:cTn id="2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 nodeType="clickPar">
                      <p:stCondLst>
                        <p:cond delay="indefinite"/>
                      </p:stCondLst>
                      <p:childTnLst>
                        <p:par>
                          <p:cTn id="2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 nodeType="clickPar">
                      <p:stCondLst>
                        <p:cond delay="indefinite"/>
                      </p:stCondLst>
                      <p:childTnLst>
                        <p:par>
                          <p:cTn id="3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 nodeType="clickPar">
                      <p:stCondLst>
                        <p:cond delay="indefinite"/>
                      </p:stCondLst>
                      <p:childTnLst>
                        <p:par>
                          <p:cTn id="3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 nodeType="clickPar">
                      <p:stCondLst>
                        <p:cond delay="indefinite"/>
                      </p:stCondLst>
                      <p:childTnLst>
                        <p:par>
                          <p:cTn id="4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 nodeType="clickPar">
                      <p:stCondLst>
                        <p:cond delay="indefinite"/>
                      </p:stCondLst>
                      <p:childTnLst>
                        <p:par>
                          <p:cTn id="4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7" fill="hold" nodeType="clickPar">
                      <p:stCondLst>
                        <p:cond delay="indefinite"/>
                      </p:stCondLst>
                      <p:childTnLst>
                        <p:par>
                          <p:cTn id="4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9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 nodeType="clickPar">
                      <p:stCondLst>
                        <p:cond delay="indefinite"/>
                      </p:stCondLst>
                      <p:childTnLst>
                        <p:par>
                          <p:cTn id="5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3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5" fill="hold" nodeType="clickPar">
                      <p:stCondLst>
                        <p:cond delay="indefinite"/>
                      </p:stCondLst>
                      <p:childTnLst>
                        <p:par>
                          <p:cTn id="5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7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9" fill="hold" nodeType="clickPar">
                      <p:stCondLst>
                        <p:cond delay="indefinite"/>
                      </p:stCondLst>
                      <p:childTnLst>
                        <p:par>
                          <p:cTn id="6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61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" fill="hold" nodeType="clickPar">
                      <p:stCondLst>
                        <p:cond delay="indefinite"/>
                      </p:stCondLst>
                      <p:childTnLst>
                        <p:par>
                          <p:cTn id="6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65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7" fill="hold" nodeType="clickPar">
                      <p:stCondLst>
                        <p:cond delay="indefinite"/>
                      </p:stCondLst>
                      <p:childTnLst>
                        <p:par>
                          <p:cTn id="6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69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1" fill="hold" nodeType="clickPar">
                      <p:stCondLst>
                        <p:cond delay="indefinite"/>
                      </p:stCondLst>
                      <p:childTnLst>
                        <p:par>
                          <p:cTn id="7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73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5" fill="hold" nodeType="clickPar">
                      <p:stCondLst>
                        <p:cond delay="indefinite"/>
                      </p:stCondLst>
                      <p:childTnLst>
                        <p:par>
                          <p:cTn id="7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77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9" fill="hold" nodeType="clickPar">
                      <p:stCondLst>
                        <p:cond delay="indefinite"/>
                      </p:stCondLst>
                      <p:childTnLst>
                        <p:par>
                          <p:cTn id="8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81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3" fill="hold" nodeType="clickPar">
                      <p:stCondLst>
                        <p:cond delay="indefinite"/>
                      </p:stCondLst>
                      <p:childTnLst>
                        <p:par>
                          <p:cTn id="8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85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7" fill="hold" nodeType="clickPar">
                      <p:stCondLst>
                        <p:cond delay="indefinite"/>
                      </p:stCondLst>
                      <p:childTnLst>
                        <p:par>
                          <p:cTn id="8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89" presetID="1" presetClass="entr" presetSubtype="0" fill="hold" nodeType="click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1" fill="hold">
                      <p:stCondLst>
                        <p:cond delay="indefinite"/>
                      </p:stCondLst>
                      <p:childTnLst>
                        <p:par>
                          <p:cTn id="92" fill="hold">
                            <p:stCondLst>
                              <p:cond delay="0"/>
                            </p:stCondLst>
                            <p:childTnLst>
                              <p:par>
                                <p:cTn id="9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4" name="Title 1">
            <a:extLst>
              <a:ext uri="{FF2B5EF4-FFF2-40B4-BE49-F238E27FC236}">
                <a16:creationId xmlns:a16="http://schemas.microsoft.com/office/drawing/2014/main" id="{6B6EB4B0-2A6C-449E-A0F4-DC37EB5A6A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08325" y="373064"/>
            <a:ext cx="6203950" cy="288925"/>
          </a:xfrm>
        </p:spPr>
        <p:txBody>
          <a:bodyPr>
            <a:noAutofit/>
          </a:bodyPr>
          <a:lstStyle/>
          <a:p>
            <a:r>
              <a:rPr lang="en-US" altLang="en-US" sz="2800" dirty="0">
                <a:solidFill>
                  <a:schemeClr val="tx1"/>
                </a:solidFill>
              </a:rPr>
              <a:t>Cross-correlations of single unit firings</a:t>
            </a:r>
          </a:p>
        </p:txBody>
      </p:sp>
      <p:pic>
        <p:nvPicPr>
          <p:cNvPr id="38915" name="Picture 2">
            <a:extLst>
              <a:ext uri="{FF2B5EF4-FFF2-40B4-BE49-F238E27FC236}">
                <a16:creationId xmlns:a16="http://schemas.microsoft.com/office/drawing/2014/main" id="{793CA25A-A11D-4676-A984-B310A056404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8962" y="872197"/>
            <a:ext cx="8287059" cy="57958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56BDCA6E-B4BF-4800-BA82-A0C2B16041C2}"/>
              </a:ext>
            </a:extLst>
          </p:cNvPr>
          <p:cNvSpPr/>
          <p:nvPr/>
        </p:nvSpPr>
        <p:spPr bwMode="auto">
          <a:xfrm>
            <a:off x="2674938" y="3295651"/>
            <a:ext cx="520700" cy="519351"/>
          </a:xfrm>
          <a:prstGeom prst="ellipse">
            <a:avLst/>
          </a:prstGeom>
          <a:noFill/>
          <a:ln w="28575" cap="flat" cmpd="sng" algn="ctr">
            <a:solidFill>
              <a:schemeClr val="accent6"/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9E02222-9942-4FB4-97AC-E91F3EDFFA9B}"/>
              </a:ext>
            </a:extLst>
          </p:cNvPr>
          <p:cNvSpPr/>
          <p:nvPr/>
        </p:nvSpPr>
        <p:spPr bwMode="auto">
          <a:xfrm>
            <a:off x="2747963" y="4992689"/>
            <a:ext cx="520700" cy="519351"/>
          </a:xfrm>
          <a:prstGeom prst="ellipse">
            <a:avLst/>
          </a:prstGeom>
          <a:noFill/>
          <a:ln w="38100" cap="flat" cmpd="sng" algn="ctr">
            <a:solidFill>
              <a:schemeClr val="accent6"/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AB4DD2AD-C033-4276-9BED-C3311BDA1610}"/>
              </a:ext>
            </a:extLst>
          </p:cNvPr>
          <p:cNvSpPr/>
          <p:nvPr/>
        </p:nvSpPr>
        <p:spPr bwMode="auto">
          <a:xfrm>
            <a:off x="3705225" y="3457576"/>
            <a:ext cx="520700" cy="519351"/>
          </a:xfrm>
          <a:prstGeom prst="ellipse">
            <a:avLst/>
          </a:prstGeom>
          <a:noFill/>
          <a:ln w="38100" cap="flat" cmpd="sng" algn="ctr">
            <a:solidFill>
              <a:schemeClr val="accent6"/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A49735D2-526A-4238-B7A4-FD8275AEA82D}"/>
              </a:ext>
            </a:extLst>
          </p:cNvPr>
          <p:cNvSpPr/>
          <p:nvPr/>
        </p:nvSpPr>
        <p:spPr bwMode="auto">
          <a:xfrm>
            <a:off x="3684588" y="4992689"/>
            <a:ext cx="519112" cy="519351"/>
          </a:xfrm>
          <a:prstGeom prst="ellipse">
            <a:avLst/>
          </a:prstGeom>
          <a:noFill/>
          <a:ln w="38100" cap="flat" cmpd="sng" algn="ctr">
            <a:solidFill>
              <a:schemeClr val="accent6"/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05A12851-A164-4341-BD86-5D2B11E9F667}"/>
              </a:ext>
            </a:extLst>
          </p:cNvPr>
          <p:cNvSpPr/>
          <p:nvPr/>
        </p:nvSpPr>
        <p:spPr bwMode="auto">
          <a:xfrm>
            <a:off x="6821488" y="3155951"/>
            <a:ext cx="525462" cy="519351"/>
          </a:xfrm>
          <a:prstGeom prst="ellipse">
            <a:avLst/>
          </a:prstGeom>
          <a:noFill/>
          <a:ln w="19050" cap="flat" cmpd="sng" algn="ctr">
            <a:solidFill>
              <a:schemeClr val="accent6"/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2184D0EC-888D-425F-A256-592FC36F6C70}"/>
              </a:ext>
            </a:extLst>
          </p:cNvPr>
          <p:cNvSpPr/>
          <p:nvPr/>
        </p:nvSpPr>
        <p:spPr bwMode="auto">
          <a:xfrm>
            <a:off x="6829426" y="4845051"/>
            <a:ext cx="525463" cy="519351"/>
          </a:xfrm>
          <a:prstGeom prst="ellipse">
            <a:avLst/>
          </a:prstGeom>
          <a:noFill/>
          <a:ln w="19050" cap="flat" cmpd="sng" algn="ctr">
            <a:solidFill>
              <a:schemeClr val="accent6"/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A63D37A7-E786-4B6D-BF8F-6ED014BDBB05}"/>
              </a:ext>
            </a:extLst>
          </p:cNvPr>
          <p:cNvSpPr/>
          <p:nvPr/>
        </p:nvSpPr>
        <p:spPr bwMode="auto">
          <a:xfrm>
            <a:off x="7823201" y="3079751"/>
            <a:ext cx="525463" cy="519351"/>
          </a:xfrm>
          <a:prstGeom prst="ellipse">
            <a:avLst/>
          </a:prstGeom>
          <a:noFill/>
          <a:ln w="19050" cap="flat" cmpd="sng" algn="ctr">
            <a:solidFill>
              <a:schemeClr val="accent6"/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8C52E609-7D90-4774-A3A0-317C93FE0B3A}"/>
              </a:ext>
            </a:extLst>
          </p:cNvPr>
          <p:cNvSpPr/>
          <p:nvPr/>
        </p:nvSpPr>
        <p:spPr bwMode="auto">
          <a:xfrm>
            <a:off x="7823201" y="4779964"/>
            <a:ext cx="525463" cy="519351"/>
          </a:xfrm>
          <a:prstGeom prst="ellipse">
            <a:avLst/>
          </a:prstGeom>
          <a:noFill/>
          <a:ln w="19050" cap="flat" cmpd="sng" algn="ctr">
            <a:solidFill>
              <a:schemeClr val="accent6"/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14" name="5-Point Star 13">
            <a:extLst>
              <a:ext uri="{FF2B5EF4-FFF2-40B4-BE49-F238E27FC236}">
                <a16:creationId xmlns:a16="http://schemas.microsoft.com/office/drawing/2014/main" id="{C5D03413-79FE-4EEC-B532-A9A920773159}"/>
              </a:ext>
            </a:extLst>
          </p:cNvPr>
          <p:cNvSpPr/>
          <p:nvPr/>
        </p:nvSpPr>
        <p:spPr bwMode="auto">
          <a:xfrm>
            <a:off x="5014475" y="1858153"/>
            <a:ext cx="556283" cy="755649"/>
          </a:xfrm>
          <a:prstGeom prst="star5">
            <a:avLst/>
          </a:prstGeom>
          <a:noFill/>
          <a:ln w="9525" cap="flat" cmpd="sng" algn="ctr">
            <a:solidFill>
              <a:schemeClr val="bg2">
                <a:lumMod val="50000"/>
              </a:schemeClr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 wrap="square"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15" name="5-Point Star 14">
            <a:extLst>
              <a:ext uri="{FF2B5EF4-FFF2-40B4-BE49-F238E27FC236}">
                <a16:creationId xmlns:a16="http://schemas.microsoft.com/office/drawing/2014/main" id="{5AD842EA-83B9-4769-883B-A467CB50B64C}"/>
              </a:ext>
            </a:extLst>
          </p:cNvPr>
          <p:cNvSpPr/>
          <p:nvPr/>
        </p:nvSpPr>
        <p:spPr bwMode="auto">
          <a:xfrm>
            <a:off x="5056679" y="3731943"/>
            <a:ext cx="556283" cy="755649"/>
          </a:xfrm>
          <a:prstGeom prst="star5">
            <a:avLst/>
          </a:prstGeom>
          <a:noFill/>
          <a:ln w="9525" cap="flat" cmpd="sng" algn="ctr">
            <a:solidFill>
              <a:schemeClr val="bg2">
                <a:lumMod val="50000"/>
              </a:schemeClr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 wrap="square"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16" name="5-Point Star 15">
            <a:extLst>
              <a:ext uri="{FF2B5EF4-FFF2-40B4-BE49-F238E27FC236}">
                <a16:creationId xmlns:a16="http://schemas.microsoft.com/office/drawing/2014/main" id="{363CD018-BDB2-4FCF-A2DB-A0D09C268E6C}"/>
              </a:ext>
            </a:extLst>
          </p:cNvPr>
          <p:cNvSpPr/>
          <p:nvPr/>
        </p:nvSpPr>
        <p:spPr bwMode="auto">
          <a:xfrm>
            <a:off x="8866163" y="3795714"/>
            <a:ext cx="520700" cy="649189"/>
          </a:xfrm>
          <a:prstGeom prst="star5">
            <a:avLst/>
          </a:prstGeom>
          <a:noFill/>
          <a:ln w="9525" cap="flat" cmpd="sng" algn="ctr">
            <a:solidFill>
              <a:schemeClr val="bg2">
                <a:lumMod val="50000"/>
              </a:schemeClr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 wrap="square"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17" name="5-Point Star 16">
            <a:extLst>
              <a:ext uri="{FF2B5EF4-FFF2-40B4-BE49-F238E27FC236}">
                <a16:creationId xmlns:a16="http://schemas.microsoft.com/office/drawing/2014/main" id="{8743E711-A72E-42CD-BAEB-31AA361BD47E}"/>
              </a:ext>
            </a:extLst>
          </p:cNvPr>
          <p:cNvSpPr/>
          <p:nvPr/>
        </p:nvSpPr>
        <p:spPr bwMode="auto">
          <a:xfrm>
            <a:off x="5070747" y="5558330"/>
            <a:ext cx="525463" cy="649188"/>
          </a:xfrm>
          <a:prstGeom prst="star5">
            <a:avLst/>
          </a:prstGeom>
          <a:noFill/>
          <a:ln w="9525" cap="flat" cmpd="sng" algn="ctr">
            <a:solidFill>
              <a:schemeClr val="bg2">
                <a:lumMod val="50000"/>
              </a:schemeClr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 wrap="square"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18" name="5-Point Star 17">
            <a:extLst>
              <a:ext uri="{FF2B5EF4-FFF2-40B4-BE49-F238E27FC236}">
                <a16:creationId xmlns:a16="http://schemas.microsoft.com/office/drawing/2014/main" id="{24C06663-CB7B-4FCC-ABFE-E0DB1FC5CBF0}"/>
              </a:ext>
            </a:extLst>
          </p:cNvPr>
          <p:cNvSpPr/>
          <p:nvPr/>
        </p:nvSpPr>
        <p:spPr bwMode="auto">
          <a:xfrm>
            <a:off x="8863214" y="5492752"/>
            <a:ext cx="520700" cy="649188"/>
          </a:xfrm>
          <a:prstGeom prst="star5">
            <a:avLst/>
          </a:prstGeom>
          <a:noFill/>
          <a:ln w="9525" cap="flat" cmpd="sng" algn="ctr">
            <a:solidFill>
              <a:schemeClr val="bg2">
                <a:lumMod val="50000"/>
              </a:schemeClr>
            </a:solidFill>
            <a:prstDash val="solid"/>
            <a:round/>
            <a:headEnd type="none" w="sm" len="sm"/>
            <a:tailEnd type="none" w="sm" len="sm"/>
          </a:ln>
          <a:effectLst/>
        </p:spPr>
        <p:txBody>
          <a:bodyPr wrap="square">
            <a:spAutoFit/>
          </a:bodyPr>
          <a:lstStyle/>
          <a:p>
            <a:pPr>
              <a:defRPr/>
            </a:pPr>
            <a:endParaRPr lang="en-US">
              <a:latin typeface="Times New Roman" charset="0"/>
            </a:endParaRP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7C897EFE-AAD5-48DD-A64A-211D51F68B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15138" y="3163888"/>
            <a:ext cx="525462" cy="649188"/>
          </a:xfrm>
          <a:prstGeom prst="ellipse">
            <a:avLst/>
          </a:prstGeom>
          <a:noFill/>
          <a:ln w="19050" algn="ctr">
            <a:solidFill>
              <a:srgbClr val="FFC000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73DFCBA1-BE1E-4C95-966F-D19DAD282D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5638" y="3155950"/>
            <a:ext cx="525462" cy="649188"/>
          </a:xfrm>
          <a:prstGeom prst="ellipse">
            <a:avLst/>
          </a:prstGeom>
          <a:noFill/>
          <a:ln w="19050" algn="ctr">
            <a:solidFill>
              <a:srgbClr val="FFC000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ED3B976D-6A05-4D18-A281-90451FBE20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8663" y="4819650"/>
            <a:ext cx="525462" cy="649188"/>
          </a:xfrm>
          <a:prstGeom prst="ellipse">
            <a:avLst/>
          </a:prstGeom>
          <a:noFill/>
          <a:ln w="19050" algn="ctr">
            <a:solidFill>
              <a:srgbClr val="FFC000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09C1A1F6-8CAD-441E-A2C7-0402140B0B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29426" y="4845050"/>
            <a:ext cx="525463" cy="649188"/>
          </a:xfrm>
          <a:prstGeom prst="ellipse">
            <a:avLst/>
          </a:prstGeom>
          <a:noFill/>
          <a:ln w="19050" algn="ctr">
            <a:solidFill>
              <a:srgbClr val="FFC000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 eaLnBrk="1" hangingPunct="1"/>
            <a:endParaRPr lang="en-US" altLang="en-US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 nodeType="clickPar">
                      <p:stCondLst>
                        <p:cond delay="indefinite"/>
                      </p:stCondLst>
                      <p:childTnLst>
                        <p:par>
                          <p:cTn id="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0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2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 nodeType="clickPar">
                      <p:stCondLst>
                        <p:cond delay="indefinite"/>
                      </p:stCondLst>
                      <p:childTnLst>
                        <p:par>
                          <p:cTn id="1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5" presetID="2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1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 nodeType="clickPar">
                      <p:stCondLst>
                        <p:cond delay="indefinite"/>
                      </p:stCondLst>
                      <p:childTnLst>
                        <p:par>
                          <p:cTn id="1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0" presetID="2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22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 nodeType="clickPar">
                      <p:stCondLst>
                        <p:cond delay="indefinite"/>
                      </p:stCondLst>
                      <p:childTnLst>
                        <p:par>
                          <p:cTn id="2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5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27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 nodeType="clickPar">
                      <p:stCondLst>
                        <p:cond delay="indefinite"/>
                      </p:stCondLst>
                      <p:childTnLst>
                        <p:par>
                          <p:cTn id="2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0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32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 nodeType="clickPar">
                      <p:stCondLst>
                        <p:cond delay="indefinite"/>
                      </p:stCondLst>
                      <p:childTnLst>
                        <p:par>
                          <p:cTn id="3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5" presetID="2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7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" fill="hold" nodeType="clickPar">
                      <p:stCondLst>
                        <p:cond delay="indefinite"/>
                      </p:stCondLst>
                      <p:childTnLst>
                        <p:par>
                          <p:cTn id="3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0" presetID="2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42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 nodeType="clickPar">
                      <p:stCondLst>
                        <p:cond delay="indefinite"/>
                      </p:stCondLst>
                      <p:childTnLst>
                        <p:par>
                          <p:cTn id="4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5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47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8" fill="hold" nodeType="clickPar">
                      <p:stCondLst>
                        <p:cond delay="indefinite"/>
                      </p:stCondLst>
                      <p:childTnLst>
                        <p:par>
                          <p:cTn id="4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0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52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3" fill="hold" nodeType="clickPar">
                      <p:stCondLst>
                        <p:cond delay="indefinite"/>
                      </p:stCondLst>
                      <p:childTnLst>
                        <p:par>
                          <p:cTn id="5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5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57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8" fill="hold" nodeType="clickPar">
                      <p:stCondLst>
                        <p:cond delay="indefinite"/>
                      </p:stCondLst>
                      <p:childTnLst>
                        <p:par>
                          <p:cTn id="5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60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62" dur="5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6" grpId="0" animBg="1"/>
      <p:bldP spid="7" grpId="0" animBg="1"/>
      <p:bldP spid="8" grpId="0" animBg="1"/>
      <p:bldP spid="9" grpId="0" animBg="1"/>
      <p:bldP spid="10" grpId="0" animBg="1"/>
      <p:bldP spid="11" grpId="0" animBg="1"/>
      <p:bldP spid="12" grpId="0" animBg="1"/>
      <p:bldP spid="19" grpId="0" animBg="1"/>
      <p:bldP spid="20" grpId="0" animBg="1"/>
      <p:bldP spid="21" grpId="0" animBg="1"/>
      <p:bldP spid="22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Widescreen</PresentationFormat>
  <Paragraphs>8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Wingdings</vt:lpstr>
      <vt:lpstr>Office Theme</vt:lpstr>
      <vt:lpstr>Cross correlations of single units.  Author: Phil Kennedy  Additional materials</vt:lpstr>
      <vt:lpstr>Cross-correlations of single unit firings</vt:lpstr>
      <vt:lpstr>Cross-correlations of single unit firing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ross-correlations of single unit firings</dc:title>
  <dc:creator>Philip Kennedy</dc:creator>
  <cp:lastModifiedBy>Philip Kennedy</cp:lastModifiedBy>
  <cp:revision>2</cp:revision>
  <dcterms:created xsi:type="dcterms:W3CDTF">2022-01-12T04:02:55Z</dcterms:created>
  <dcterms:modified xsi:type="dcterms:W3CDTF">2022-01-19T03:45:10Z</dcterms:modified>
</cp:coreProperties>
</file>